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60" r:id="rId5"/>
    <p:sldId id="261" r:id="rId6"/>
    <p:sldId id="262" r:id="rId7"/>
    <p:sldId id="263" r:id="rId8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8" d="100"/>
          <a:sy n="68" d="100"/>
        </p:scale>
        <p:origin x="-1446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2DAD85-92FE-4867-9B29-E91B94611F0B}" type="datetimeFigureOut">
              <a:rPr lang="en-US" smtClean="0"/>
              <a:pPr/>
              <a:t>3/29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91C66D-3557-46EF-9AEA-88E974BD7756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-1" y="-6"/>
          <a:ext cx="9144001" cy="6669354"/>
        </p:xfrm>
        <a:graphic>
          <a:graphicData uri="http://schemas.openxmlformats.org/drawingml/2006/table">
            <a:tbl>
              <a:tblPr rtl="1"/>
              <a:tblGrid>
                <a:gridCol w="254376"/>
                <a:gridCol w="1790728"/>
                <a:gridCol w="1790728"/>
                <a:gridCol w="970328"/>
                <a:gridCol w="1179219"/>
                <a:gridCol w="2268312"/>
                <a:gridCol w="890310"/>
              </a:tblGrid>
              <a:tr h="414800">
                <a:tc gridSpan="7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Supplementary Table </a:t>
                      </a: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A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. 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Bacterial α-amylases and amylopullulanases used for multiple sequence alignment and </a:t>
                      </a:r>
                      <a:r>
                        <a:rPr lang="en-US" sz="800" dirty="0" err="1">
                          <a:latin typeface="Times New Roman"/>
                          <a:ea typeface="Calibri"/>
                          <a:cs typeface="Arial"/>
                        </a:rPr>
                        <a:t>phylogenetic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 tree.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14800">
                <a:tc>
                  <a:txBody>
                    <a:bodyPr/>
                    <a:lstStyle/>
                    <a:p>
                      <a:pPr algn="just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ccession No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α-amylas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ccession No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mylopullulanas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Famil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A2193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. hydrophila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S4756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. gottschalkii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GH1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DZ9936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licyclo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</a:t>
                      </a: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P4501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. horikoshii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GT2049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. macleodii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EW2343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noxy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 LM1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L1474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. flavitherm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C6015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acidopullulytic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W3249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. gottschalkii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FP8996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cere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FI4945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noxy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</a:t>
                      </a: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.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BAB1851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flavocaldari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ER6812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aquimari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S3653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 KSM-137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A2219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amyloliquefacien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BAA0583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 dirty="0">
                          <a:latin typeface="Times New Roman"/>
                          <a:ea typeface="Calibri"/>
                          <a:cs typeface="Arial"/>
                        </a:rPr>
                        <a:t>Bacillus 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sp. XAL601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D2669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Y8903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breve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UCC200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BAF9348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. haloduran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FI7075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 dirty="0">
                          <a:latin typeface="Times New Roman"/>
                          <a:ea typeface="Calibri"/>
                          <a:cs typeface="Arial"/>
                        </a:rPr>
                        <a:t>G. </a:t>
                      </a:r>
                      <a:r>
                        <a:rPr lang="en-US" sz="800" i="1" dirty="0" err="1">
                          <a:latin typeface="Times New Roman"/>
                          <a:ea typeface="Calibri"/>
                          <a:cs typeface="Arial"/>
                        </a:rPr>
                        <a:t>thermoleovorans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F0056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ytophaga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A3643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K. pneumonia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D4707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. acetobutylicum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BAF9390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L. plantarum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FZ4119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Exiguobacterium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G3395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k. pneumonia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BL7740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Geo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</a:t>
                      </a:r>
                      <a:r>
                        <a:rPr lang="ar-SA" sz="800" i="1">
                          <a:latin typeface="Times New Roman"/>
                          <a:ea typeface="Calibri"/>
                          <a:cs typeface="Arial"/>
                        </a:rPr>
                        <a:t>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BY9579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pseudethanolicus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B9296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H. meridiana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A1980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saccharolyticum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N5252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H. orenii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A2320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thermohydrosulfuric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D4524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L. manihotivoran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BAB6209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thermophil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L0740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Paeni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C1381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M. pulmoni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A4079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S.grise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B0084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thermosulfurigene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A8855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S. limos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EOD0178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. bacterium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L21-TH-D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B3656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S. venezuela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S8154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thermophi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HB2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8243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AA7219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maritima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MSB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8243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A2759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X. campestri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8243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HD1866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maritima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AD3690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maritima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GH5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CK4196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D. turgidum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ACI2027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yellowstonii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DSM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07401"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  <a:tabLst>
                          <a:tab pos="581660" algn="l"/>
                          <a:tab pos="1163320" algn="l"/>
                          <a:tab pos="1744980" algn="l"/>
                          <a:tab pos="2326640" algn="l"/>
                          <a:tab pos="2908300" algn="l"/>
                          <a:tab pos="3489960" algn="l"/>
                          <a:tab pos="4071620" algn="l"/>
                          <a:tab pos="4653280" algn="l"/>
                          <a:tab pos="5234940" algn="l"/>
                          <a:tab pos="5816600" algn="l"/>
                          <a:tab pos="6398260" algn="l"/>
                          <a:tab pos="6979920" algn="l"/>
                          <a:tab pos="7561580" algn="l"/>
                          <a:tab pos="8143240" algn="l"/>
                          <a:tab pos="8724900" algn="l"/>
                          <a:tab pos="930656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BAD6998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. thermophi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HB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52484" marR="52484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ar-SA" sz="800" dirty="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52484" marR="52484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395536" y="1484782"/>
          <a:ext cx="8352928" cy="3888429"/>
        </p:xfrm>
        <a:graphic>
          <a:graphicData uri="http://schemas.openxmlformats.org/drawingml/2006/table">
            <a:tbl>
              <a:tblPr/>
              <a:tblGrid>
                <a:gridCol w="2568720"/>
                <a:gridCol w="2892104"/>
                <a:gridCol w="2892104"/>
              </a:tblGrid>
              <a:tr h="254979">
                <a:tc gridSpan="3"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b="1" dirty="0" smtClean="0">
                          <a:latin typeface="Times New Roman"/>
                          <a:ea typeface="Calibri"/>
                          <a:cs typeface="Arial"/>
                        </a:rPr>
                        <a:t>Supplementary Table </a:t>
                      </a:r>
                      <a:r>
                        <a:rPr lang="en-US" sz="1000" b="1" dirty="0" smtClean="0">
                          <a:latin typeface="Times New Roman"/>
                          <a:ea typeface="Calibri"/>
                          <a:cs typeface="Arial"/>
                        </a:rPr>
                        <a:t>B. </a:t>
                      </a:r>
                      <a:r>
                        <a:rPr lang="en-US" sz="1000" dirty="0">
                          <a:latin typeface="Times New Roman"/>
                          <a:ea typeface="Calibri"/>
                          <a:cs typeface="Arial"/>
                        </a:rPr>
                        <a:t>The % identity of proteins from this study with other Amylopullulanase.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2"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% Identity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318723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10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Cohnella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 sp. A01 0083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Cohnella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 sp. A01 01133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C. bacterium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 L21-TH-D2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4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B. cereus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Bacillus sp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. XAL60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3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B. breve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 UCC2003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2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T. saccharolyticum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2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T. thermohydrosulfuricus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4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9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T. maritima 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MSB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6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A. gottschalkii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5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Anoxybacillus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 sp. LM18-11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9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L. plantarum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24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39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M. pulmonis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4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47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54979">
                <a:tc>
                  <a:txBody>
                    <a:bodyPr/>
                    <a:lstStyle/>
                    <a:p>
                      <a:pPr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i="1">
                          <a:latin typeface="Times New Roman"/>
                          <a:ea typeface="Calibri"/>
                          <a:cs typeface="Arial"/>
                        </a:rPr>
                        <a:t>D. turgidum</a:t>
                      </a: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 (GH57)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>
                          <a:latin typeface="Times New Roman"/>
                          <a:ea typeface="Calibri"/>
                          <a:cs typeface="Arial"/>
                        </a:rPr>
                        <a:t>5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1000" dirty="0">
                          <a:latin typeface="Times New Roman"/>
                          <a:ea typeface="Calibri"/>
                          <a:cs typeface="Arial"/>
                        </a:rPr>
                        <a:t>37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79511" y="1484776"/>
          <a:ext cx="8964489" cy="4104459"/>
        </p:xfrm>
        <a:graphic>
          <a:graphicData uri="http://schemas.openxmlformats.org/drawingml/2006/table">
            <a:tbl>
              <a:tblPr rtl="1"/>
              <a:tblGrid>
                <a:gridCol w="675627"/>
                <a:gridCol w="675627"/>
                <a:gridCol w="840384"/>
                <a:gridCol w="840384"/>
                <a:gridCol w="587914"/>
                <a:gridCol w="504350"/>
                <a:gridCol w="1004549"/>
                <a:gridCol w="772228"/>
                <a:gridCol w="673846"/>
                <a:gridCol w="1859747"/>
                <a:gridCol w="529833"/>
              </a:tblGrid>
              <a:tr h="562186">
                <a:tc gridSpan="11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Supplementary </a:t>
                      </a:r>
                      <a:r>
                        <a:rPr lang="en-US" sz="800" b="1" dirty="0">
                          <a:latin typeface="Times New Roman"/>
                          <a:ea typeface="Calibri"/>
                          <a:cs typeface="Arial"/>
                        </a:rPr>
                        <a:t>Table </a:t>
                      </a: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C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. 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Molecular weight, pH optimum, temperature optimum and Kinetic parameters of some amylopullulanases from GH13 and GH57. 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(S = Starch, P = pullulan)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48723"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Ref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cat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/ 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m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cat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(s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-1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V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max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(µmol/min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m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(mg/ml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ubstrat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Temperatur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Optimum (</a:t>
                      </a:r>
                      <a:r>
                        <a:rPr lang="en-US" sz="800">
                          <a:latin typeface="Times New Roman"/>
                          <a:ea typeface="MTSY"/>
                          <a:cs typeface="Arial"/>
                        </a:rPr>
                        <a:t>˚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)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H optimum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Molecular weight (kDa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train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Famil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This stud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14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00.7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.37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Cambria Math"/>
                          <a:ea typeface="MTSY"/>
                          <a:cs typeface="Cambria Math"/>
                        </a:rPr>
                        <a:t>∼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6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ohnella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sp.A01 0083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88.2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647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189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algn="l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This stud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07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16.7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09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Cambria Math"/>
                          <a:ea typeface="MTSY"/>
                          <a:cs typeface="Cambria Math"/>
                        </a:rPr>
                        <a:t>∼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 125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ohnella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sp.A01 0113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6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44.30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.4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7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1683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2.9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2× 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48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Geo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 L1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GH1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168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.2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1.1× 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8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[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2] 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.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8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9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1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Lactobacillus plantarum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L137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.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5.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.7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3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32.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.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9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2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</a:t>
                      </a: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 XAL60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.4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4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9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6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hermoanaerobacter ethanolic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9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ar-SA" sz="8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5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1.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28.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1.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hermoanaerobacter pseudoethanolic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7.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98.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6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2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Bacillus circulan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F-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ar-SA" sz="800" dirty="0">
                          <a:latin typeface="Calibri"/>
                          <a:ea typeface="Calibri"/>
                          <a:cs typeface="Times New Roman"/>
                        </a:rPr>
                        <a:t> 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7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4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Halorubrum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</a:t>
                      </a: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8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.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2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Anoxybacillus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p. SK3-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0536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0536"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9]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Desulfurococcus mucosu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/>
        </p:nvGraphicFramePr>
        <p:xfrm>
          <a:off x="158112" y="1484776"/>
          <a:ext cx="8985888" cy="4248475"/>
        </p:xfrm>
        <a:graphic>
          <a:graphicData uri="http://schemas.openxmlformats.org/drawingml/2006/table">
            <a:tbl>
              <a:tblPr rtl="1"/>
              <a:tblGrid>
                <a:gridCol w="675627"/>
                <a:gridCol w="675627"/>
                <a:gridCol w="840384"/>
                <a:gridCol w="840384"/>
                <a:gridCol w="587914"/>
                <a:gridCol w="504350"/>
                <a:gridCol w="1004549"/>
                <a:gridCol w="772228"/>
                <a:gridCol w="673846"/>
                <a:gridCol w="1859747"/>
                <a:gridCol w="551232"/>
              </a:tblGrid>
              <a:tr h="581912">
                <a:tc gridSpan="11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Supplementary Table </a:t>
                      </a: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C </a:t>
                      </a:r>
                      <a:r>
                        <a:rPr lang="en-US" sz="800" b="1" dirty="0" smtClean="0">
                          <a:latin typeface="Times New Roman"/>
                          <a:ea typeface="Calibri"/>
                          <a:cs typeface="Arial"/>
                        </a:rPr>
                        <a:t>continue</a:t>
                      </a: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. 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Molecular weight, pH optimum, temperature optimum and Kinetic parameters of some amylopullulanases from GH13 and GH57. 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(S = Starch, P = pullulan)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464468"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Ref.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cat 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/ 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m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cat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(s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-1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V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max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(µmol/min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K</a:t>
                      </a:r>
                      <a:r>
                        <a:rPr lang="en-US" sz="800" baseline="-25000">
                          <a:latin typeface="Times New Roman"/>
                          <a:ea typeface="Calibri"/>
                          <a:cs typeface="Arial"/>
                        </a:rPr>
                        <a:t>m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(mg/ml)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ubstrat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Temperature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Optimum (</a:t>
                      </a:r>
                      <a:r>
                        <a:rPr lang="en-US" sz="800">
                          <a:latin typeface="Times New Roman"/>
                          <a:ea typeface="MTSY"/>
                          <a:cs typeface="Arial"/>
                        </a:rPr>
                        <a:t>˚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C)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H optimum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Molecular weight (</a:t>
                      </a:r>
                      <a:r>
                        <a:rPr lang="en-US" sz="800" dirty="0" err="1">
                          <a:latin typeface="Times New Roman"/>
                          <a:ea typeface="Calibri"/>
                          <a:cs typeface="Arial"/>
                        </a:rPr>
                        <a:t>kDa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)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Strains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Famil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This stud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14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00.7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.37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Cambria Math"/>
                          <a:ea typeface="MTSY"/>
                          <a:cs typeface="Cambria Math"/>
                        </a:rPr>
                        <a:t>∼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6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ohnella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sp.A01 0083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88.2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6471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189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algn="l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This study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07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16.7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09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Cambria Math"/>
                          <a:ea typeface="MTSY"/>
                          <a:cs typeface="Cambria Math"/>
                        </a:rPr>
                        <a:t>∼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 125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Cohnella</a:t>
                      </a: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 sp.A01 0113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l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6×10</a:t>
                      </a:r>
                      <a:r>
                        <a:rPr lang="en-US" sz="800" baseline="30000">
                          <a:latin typeface="Times New Roman"/>
                          <a:ea typeface="Calibri"/>
                          <a:cs typeface="Arial"/>
                        </a:rPr>
                        <a:t>4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444.302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.4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0.279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219111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0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32.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.6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5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5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50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 dirty="0" err="1" smtClean="0">
                          <a:latin typeface="Times New Roman"/>
                          <a:ea typeface="Calibri"/>
                          <a:cs typeface="Arial"/>
                        </a:rPr>
                        <a:t>Pyrococcus</a:t>
                      </a:r>
                      <a:r>
                        <a:rPr lang="en-US" sz="800" i="1" dirty="0" smtClean="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US" sz="800" i="1" dirty="0" err="1" smtClean="0">
                          <a:latin typeface="Times New Roman"/>
                          <a:ea typeface="Calibri"/>
                          <a:cs typeface="Arial"/>
                        </a:rPr>
                        <a:t>furiosus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GH57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219111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.4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1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.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8.0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9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9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Pyrococcus woesei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3.3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5.5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.7 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2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32.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.6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95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5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2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hermococcus hydrothermalis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8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2.48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3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0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7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hermococcus kodakarensis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6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P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98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5.5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119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Thermococcus litoralis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S</a:t>
                      </a: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4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>
                          <a:latin typeface="Times New Roman"/>
                          <a:ea typeface="Calibri"/>
                          <a:cs typeface="Arial"/>
                        </a:rPr>
                        <a:t>-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>
                          <a:latin typeface="Times New Roman"/>
                          <a:ea typeface="Calibri"/>
                          <a:cs typeface="Arial"/>
                        </a:rPr>
                        <a:t>Dictyoglomus turgidum</a:t>
                      </a:r>
                      <a:endParaRPr lang="en-US" sz="11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[15]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 smtClean="0">
                          <a:latin typeface="Times New Roman"/>
                          <a:ea typeface="Calibri"/>
                          <a:cs typeface="Arial"/>
                        </a:rPr>
                        <a:t>90</a:t>
                      </a: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6.0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96.3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r>
                        <a:rPr lang="en-US" sz="800" i="1" dirty="0" err="1">
                          <a:latin typeface="Times New Roman"/>
                          <a:ea typeface="Calibri"/>
                          <a:cs typeface="Arial"/>
                        </a:rPr>
                        <a:t>Thermotoga</a:t>
                      </a:r>
                      <a:r>
                        <a:rPr lang="en-US" sz="800" i="1" dirty="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US" sz="800" i="1" dirty="0" err="1">
                          <a:latin typeface="Times New Roman"/>
                          <a:ea typeface="Calibri"/>
                          <a:cs typeface="Arial"/>
                        </a:rPr>
                        <a:t>maritima</a:t>
                      </a:r>
                      <a:r>
                        <a:rPr lang="en-US" sz="800" i="1" dirty="0">
                          <a:latin typeface="Times New Roman"/>
                          <a:ea typeface="Calibri"/>
                          <a:cs typeface="Arial"/>
                        </a:rPr>
                        <a:t> </a:t>
                      </a:r>
                      <a:r>
                        <a:rPr lang="en-US" sz="800" dirty="0">
                          <a:latin typeface="Times New Roman"/>
                          <a:ea typeface="Calibri"/>
                          <a:cs typeface="Arial"/>
                        </a:rPr>
                        <a:t>MSB8</a:t>
                      </a:r>
                      <a:endParaRPr lang="en-US" sz="11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68580" marR="685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rowSpan="2">
                  <a:txBody>
                    <a:bodyPr/>
                    <a:lstStyle/>
                    <a:p>
                      <a:pPr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  <a:tr h="145467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1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ar-SA" sz="800">
                        <a:latin typeface="Calibri"/>
                        <a:ea typeface="Calibri"/>
                        <a:cs typeface="Times New Roman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</a:tr>
              <a:tr h="145467"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0"/>
                        </a:spcAf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Calibri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rtl="0">
                        <a:lnSpc>
                          <a:spcPct val="115000"/>
                        </a:lnSpc>
                        <a:spcAft>
                          <a:spcPts val="1000"/>
                        </a:spcAft>
                        <a:tabLst>
                          <a:tab pos="6097270" algn="l"/>
                        </a:tabLst>
                      </a:pPr>
                      <a:endParaRPr lang="en-US" sz="800" dirty="0">
                        <a:latin typeface="Times New Roman"/>
                        <a:ea typeface="Calibri"/>
                        <a:cs typeface="Arial"/>
                      </a:endParaRPr>
                    </a:p>
                  </a:txBody>
                  <a:tcPr marL="45530" marR="4553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</a:tr>
            </a:tbl>
          </a:graphicData>
        </a:graphic>
      </p:graphicFrame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/>
          <p:nvPr/>
        </p:nvPicPr>
        <p:blipFill>
          <a:blip r:embed="rId2" cstate="print">
            <a:extLst>
              <a:ext uri="{28A0092B-C50C-407E-A947-70E740481C1C}">
                <a14:useLocalDpi xmlns:lc="http://schemas.openxmlformats.org/drawingml/2006/lockedCanvas" xmlns:pic="http://schemas.openxmlformats.org/drawingml/2006/picture" xmlns:arto="http://schemas.microsoft.com/office/word/2006/arto" xmlns:a14="http://schemas.microsoft.com/office/drawing/2010/main" xmlns:wps="http://schemas.microsoft.com/office/word/2010/wordprocessingShape" xmlns:wpi="http://schemas.microsoft.com/office/word/2010/wordprocessingInk" xmlns:wpg="http://schemas.microsoft.com/office/word/2010/wordprocessingGroup" xmlns:w14="http://schemas.microsoft.com/office/word/2010/wordml" xmlns:w="http://schemas.openxmlformats.org/wordprocessingml/2006/main" xmlns:w10="urn:schemas-microsoft-com:office:word" xmlns:wp14="http://schemas.microsoft.com/office/word/2010/wordprocessingDrawing" xmlns:v="urn:schemas-microsoft-com:vml" xmlns:o="urn:schemas-microsoft-com:office:office" xmlns:mc="http://schemas.openxmlformats.org/markup-compatibility/2006" xmlns:wpc="http://schemas.microsoft.com/office/word/2010/wordprocessingCanvas" xmlns="" xmlns:wne="http://schemas.microsoft.com/office/word/2006/wordml" xmlns:wp="http://schemas.openxmlformats.org/drawingml/2006/wordprocessingDrawing" xmlns:m="http://schemas.openxmlformats.org/officeDocument/2006/math" xmlns:ve="http://schemas.openxmlformats.org/markup-compatibility/2006" val="0"/>
              </a:ext>
            </a:extLst>
          </a:blip>
          <a:srcRect/>
          <a:stretch>
            <a:fillRect/>
          </a:stretch>
        </p:blipFill>
        <p:spPr bwMode="auto">
          <a:xfrm>
            <a:off x="251520" y="836712"/>
            <a:ext cx="8568952" cy="3384376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TextBox 4"/>
          <p:cNvSpPr txBox="1"/>
          <p:nvPr/>
        </p:nvSpPr>
        <p:spPr>
          <a:xfrm>
            <a:off x="251520" y="4869160"/>
            <a:ext cx="8892480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dirty="0" err="1" smtClean="0">
                <a:latin typeface="Times New Roman" pitchFamily="18" charset="0"/>
                <a:cs typeface="Times New Roman" pitchFamily="18" charset="0"/>
              </a:rPr>
              <a:t>Supplrmrntry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 figure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A. </a:t>
            </a:r>
            <a:r>
              <a:rPr lang="en-US" dirty="0" smtClean="0">
                <a:latin typeface="Times New Roman" pitchFamily="18" charset="0"/>
                <a:cs typeface="Times New Roman" pitchFamily="18" charset="0"/>
              </a:rPr>
              <a:t>Chromatogram 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of  Ni-NTA </a:t>
            </a:r>
            <a:r>
              <a:rPr lang="en-US" dirty="0" err="1">
                <a:latin typeface="Times New Roman" pitchFamily="18" charset="0"/>
                <a:cs typeface="Times New Roman" pitchFamily="18" charset="0"/>
              </a:rPr>
              <a:t>sepharose</a:t>
            </a:r>
            <a:r>
              <a:rPr lang="en-US" dirty="0">
                <a:latin typeface="Times New Roman" pitchFamily="18" charset="0"/>
                <a:cs typeface="Times New Roman" pitchFamily="18" charset="0"/>
              </a:rPr>
              <a:t> column (c1), chromatogram of  ion exchange chromatography (c2)</a:t>
            </a:r>
          </a:p>
          <a:p>
            <a:pPr algn="ctr"/>
            <a:endParaRPr lang="en-US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476672"/>
            <a:ext cx="8229600" cy="5649491"/>
          </a:xfrm>
        </p:spPr>
        <p:txBody>
          <a:bodyPr>
            <a:normAutofit/>
          </a:bodyPr>
          <a:lstStyle/>
          <a:p>
            <a:pPr algn="just">
              <a:buNone/>
            </a:pP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efrence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Nish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atyanarayan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. Characterization of recombinant amylopullulanase (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gt-apu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and truncated amylopullulanase (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gt-apu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of the extrem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hermophile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Geobacill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ermoleovoran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NP33 and their action in starch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accharificati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crob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techn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2013;97(14):6279-92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o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10.1007/s00253-012-4538-6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MID: 23132347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2] Kim JH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unako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, Ono H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urook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Y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ukusak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, Yamashita M. Characterization of gene encoding amylopullulanase from plant-originated lactic acid bacterium,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Lactobacillus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plantaru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L137. J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sc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en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2008;106(5):449-59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pu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2008/12/30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o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10.1263/jbb.106.449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MID: 19111640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3] Lee SP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orikaw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, Takagi M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Imanak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T. Cloning of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ap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ene and characterization of its product, alpha-amylase-pullulanase (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ap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, from thermophilic and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lkaliphil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Bacillus Sp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strain Xal601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nviron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crob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1994;60:3764-73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4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athupal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P, Lowe SE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odkovyrov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M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Zeik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JG. Sequencing of the amylopullulanase (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u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gene of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ermoanaerobacter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ethanolic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39E, and identification of the active site by site-directed mutagenesis. J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hem. 1993;268(22):16332-44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pu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1993/08/05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MID: 8344920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5] Lin FP, Ho YH, Lin HY, Lin HJ. Effect of C-terminal truncation on enzyme properties of recombinant amylopullulanase from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ermoanaerobacter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pseudoethanolic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Extremophiles. 2012:1-9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6] Kim CH, Kim YS. Substrate specificity and detailed characterization of a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functiona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mylase‐pullulanase enzyme from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Bacillus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circulan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F‐2 having two different active sites on one polypeptide. European Journal of Biochemistry 1995;227:687-93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7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Siroos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moozega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A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Khajeh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K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Fazel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abib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ezae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. Purification and characterization of a novel extracellula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alophil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nd organic solvent-tolerant amylopullulanase from the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Haloarchaeon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halorubrum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sp. Strain Ha25. Extremophiles. 2014;18:25-33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8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Xuefen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H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oku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L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Ganj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R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Zhibiao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Z, Yan L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Zhon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H. Gene cloning and characterization of an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α-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mylase from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Alteromona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cleodii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7 f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nteromorph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olysaccharide degradation. Journal of Microbiology and Biotechnology. 2014;24(2):254-63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9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uffne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ertoldo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, Andersen JT, Wagner K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ntranikia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. A new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hermoactiv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ullulanase from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esulfurococc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ucos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cloning, sequencing, purification, and characterization of the recombinant enzyme after expression in 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Bacillus subtil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J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acter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2000;182(22):6331-8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pu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2000/10/29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MID: 11053376;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entral PMCID: PMC94778.</a:t>
            </a: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a-I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57200" y="476672"/>
            <a:ext cx="8229600" cy="5649491"/>
          </a:xfrm>
        </p:spPr>
        <p:txBody>
          <a:bodyPr>
            <a:normAutofit/>
          </a:bodyPr>
          <a:lstStyle/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0] Brown SH, Kelly RM. Characterization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mylolyt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nzymes, having both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α-1, 4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α-1, 6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ydrolytic activity, from the thermophilic archaea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Pyrococc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furios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ermococc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litoral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nviron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crob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1993;59:2614-21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1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Rüdiger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, Jorgensen PL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ntranikia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G. Isolation and characterization of a heat-stable pullulanase from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yperthermophil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rchae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Pyrococc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woesei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fter cloning and expression of its gene in Escherichia coli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Environ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crob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1995;61(2):567-75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2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rra-Pujada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ebeir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uchir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O’Donohue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MJ. The type II pullulanase of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hermococc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ydrothermali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molecular characterization of the gene and expression of the catalytic domain. J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acter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1999;181(10):3284-7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3] Han T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Zeng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, Li Z, Liu L, Wei M, Guan Q, et al. Biochemical characterization of a recombinant pullulanase from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ermococcu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kodakarensis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KOD1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Lett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Microbi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2013;57(4):336-43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pub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2013/06/25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oi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: 10.1111/lam.12118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PubMed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MID: 23789737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4]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rum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P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ermanso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S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ochestien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,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oyu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J. Mining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Dictyoglomus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turgidu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for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enzymaticall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activ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carbohydrases'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che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techn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App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chem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Biotechno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2011;163:205-14.</a:t>
            </a:r>
          </a:p>
          <a:p>
            <a:pPr algn="just">
              <a:buNone/>
            </a:pP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15] Lim WJ, Park SR, Long An C, Lee JY, Hong SY, Shin EC, et al. Cloning and characterization of a thermostable intracellular </a:t>
            </a:r>
            <a:r>
              <a:rPr lang="el-GR" sz="1200" dirty="0" smtClean="0">
                <a:latin typeface="Times New Roman" pitchFamily="18" charset="0"/>
                <a:cs typeface="Times New Roman" pitchFamily="18" charset="0"/>
              </a:rPr>
              <a:t>α-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mylase gene from the </a:t>
            </a:r>
            <a:r>
              <a:rPr lang="en-US" sz="1200" dirty="0" err="1" smtClean="0">
                <a:latin typeface="Times New Roman" pitchFamily="18" charset="0"/>
                <a:cs typeface="Times New Roman" pitchFamily="18" charset="0"/>
              </a:rPr>
              <a:t>hyperthermophilic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bacterium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Thermotog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i="1" dirty="0" err="1" smtClean="0">
                <a:latin typeface="Times New Roman" pitchFamily="18" charset="0"/>
                <a:cs typeface="Times New Roman" pitchFamily="18" charset="0"/>
              </a:rPr>
              <a:t>maritima</a:t>
            </a:r>
            <a:r>
              <a:rPr lang="en-US" sz="1200" i="1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Msb8. Research in Microbiology. 2003;154:681-87.</a:t>
            </a: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>
              <a:buNone/>
            </a:pP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  <a:p>
            <a:pPr algn="just"/>
            <a:endParaRPr lang="fa-IR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</TotalTime>
  <Words>1481</Words>
  <Application>Microsoft Office PowerPoint</Application>
  <PresentationFormat>On-screen Show (4:3)</PresentationFormat>
  <Paragraphs>417</Paragraphs>
  <Slides>7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8" baseType="lpstr">
      <vt:lpstr>Office Theme</vt:lpstr>
      <vt:lpstr>Slide 1</vt:lpstr>
      <vt:lpstr>Slide 2</vt:lpstr>
      <vt:lpstr>Slide 3</vt:lpstr>
      <vt:lpstr>Slide 4</vt:lpstr>
      <vt:lpstr>Slide 5</vt:lpstr>
      <vt:lpstr>Slide 6</vt:lpstr>
      <vt:lpstr>Slide 7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sus</dc:creator>
  <cp:lastModifiedBy>asus</cp:lastModifiedBy>
  <cp:revision>18</cp:revision>
  <dcterms:created xsi:type="dcterms:W3CDTF">2017-03-02T10:36:29Z</dcterms:created>
  <dcterms:modified xsi:type="dcterms:W3CDTF">2017-03-29T19:10:43Z</dcterms:modified>
</cp:coreProperties>
</file>